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256" r:id="rId5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E0E25C61-25B8-41DD-B149-A94F91FE37F6}" v="2" dt="2026-03-31T00:54:23.417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123" d="100"/>
          <a:sy n="123" d="100"/>
        </p:scale>
        <p:origin x="88" y="10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11" Type="http://schemas.microsoft.com/office/2015/10/relationships/revisionInfo" Target="revisionInfo.xml"/><Relationship Id="rId5" Type="http://schemas.openxmlformats.org/officeDocument/2006/relationships/slide" Target="slides/slide1.xml"/><Relationship Id="rId10" Type="http://schemas.microsoft.com/office/2016/11/relationships/changesInfo" Target="changesInfos/changesInfo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辰巳　めぐみ" userId="S::megumi_tatsumi@ncnp.go.jp::88b1893c-db63-4bb5-9dca-a6ce3447aab8" providerId="AD" clId="Web-{E0E25C61-25B8-41DD-B149-A94F91FE37F6}"/>
    <pc:docChg chg="modSld">
      <pc:chgData name="辰巳　めぐみ" userId="S::megumi_tatsumi@ncnp.go.jp::88b1893c-db63-4bb5-9dca-a6ce3447aab8" providerId="AD" clId="Web-{E0E25C61-25B8-41DD-B149-A94F91FE37F6}" dt="2026-03-31T00:54:23.417" v="0" actId="20577"/>
      <pc:docMkLst>
        <pc:docMk/>
      </pc:docMkLst>
      <pc:sldChg chg="modSp">
        <pc:chgData name="辰巳　めぐみ" userId="S::megumi_tatsumi@ncnp.go.jp::88b1893c-db63-4bb5-9dca-a6ce3447aab8" providerId="AD" clId="Web-{E0E25C61-25B8-41DD-B149-A94F91FE37F6}" dt="2026-03-31T00:54:23.417" v="0" actId="20577"/>
        <pc:sldMkLst>
          <pc:docMk/>
          <pc:sldMk cId="3285713202" sldId="256"/>
        </pc:sldMkLst>
        <pc:spChg chg="mod">
          <ac:chgData name="辰巳　めぐみ" userId="S::megumi_tatsumi@ncnp.go.jp::88b1893c-db63-4bb5-9dca-a6ce3447aab8" providerId="AD" clId="Web-{E0E25C61-25B8-41DD-B149-A94F91FE37F6}" dt="2026-03-31T00:54:23.417" v="0" actId="20577"/>
          <ac:spMkLst>
            <pc:docMk/>
            <pc:sldMk cId="3285713202" sldId="256"/>
            <ac:spMk id="5" creationId="{131A1956-03FD-E9AD-3AD1-02E5585409FB}"/>
          </ac:spMkLst>
        </pc:spChg>
      </pc:sldChg>
    </pc:docChg>
  </pc:docChgLst>
  <pc:docChgLst>
    <pc:chgData name="辰巳　めぐみ" userId="88b1893c-db63-4bb5-9dca-a6ce3447aab8" providerId="ADAL" clId="{4C98BF49-9253-44F8-8335-0E5DA0562794}"/>
    <pc:docChg chg="custSel modSld">
      <pc:chgData name="辰巳　めぐみ" userId="88b1893c-db63-4bb5-9dca-a6ce3447aab8" providerId="ADAL" clId="{4C98BF49-9253-44F8-8335-0E5DA0562794}" dt="2026-03-25T03:04:14.603" v="162" actId="1076"/>
      <pc:docMkLst>
        <pc:docMk/>
      </pc:docMkLst>
      <pc:sldChg chg="addSp delSp modSp mod">
        <pc:chgData name="辰巳　めぐみ" userId="88b1893c-db63-4bb5-9dca-a6ce3447aab8" providerId="ADAL" clId="{4C98BF49-9253-44F8-8335-0E5DA0562794}" dt="2026-03-25T03:04:14.603" v="162" actId="1076"/>
        <pc:sldMkLst>
          <pc:docMk/>
          <pc:sldMk cId="3285713202" sldId="256"/>
        </pc:sldMkLst>
        <pc:picChg chg="add mod ord">
          <ac:chgData name="辰巳　めぐみ" userId="88b1893c-db63-4bb5-9dca-a6ce3447aab8" providerId="ADAL" clId="{4C98BF49-9253-44F8-8335-0E5DA0562794}" dt="2026-03-25T03:00:51.829" v="134" actId="1076"/>
          <ac:picMkLst>
            <pc:docMk/>
            <pc:sldMk cId="3285713202" sldId="256"/>
            <ac:picMk id="3" creationId="{743BD14A-99BE-64D9-9D9E-031796357518}"/>
          </ac:picMkLst>
        </pc:picChg>
        <pc:picChg chg="add mod ord">
          <ac:chgData name="辰巳　めぐみ" userId="88b1893c-db63-4bb5-9dca-a6ce3447aab8" providerId="ADAL" clId="{4C98BF49-9253-44F8-8335-0E5DA0562794}" dt="2026-03-25T03:01:30.058" v="142" actId="1076"/>
          <ac:picMkLst>
            <pc:docMk/>
            <pc:sldMk cId="3285713202" sldId="256"/>
            <ac:picMk id="24" creationId="{54745168-3CA5-5119-F4D0-30D4D0E88D84}"/>
          </ac:picMkLst>
        </pc:picChg>
        <pc:picChg chg="add mod ord">
          <ac:chgData name="辰巳　めぐみ" userId="88b1893c-db63-4bb5-9dca-a6ce3447aab8" providerId="ADAL" clId="{4C98BF49-9253-44F8-8335-0E5DA0562794}" dt="2026-03-25T03:03:15.756" v="148" actId="1076"/>
          <ac:picMkLst>
            <pc:docMk/>
            <pc:sldMk cId="3285713202" sldId="256"/>
            <ac:picMk id="25" creationId="{6FD8FB6A-0C8E-A619-0F95-BCD829D560D4}"/>
          </ac:picMkLst>
        </pc:picChg>
        <pc:picChg chg="add mod ord">
          <ac:chgData name="辰巳　めぐみ" userId="88b1893c-db63-4bb5-9dca-a6ce3447aab8" providerId="ADAL" clId="{4C98BF49-9253-44F8-8335-0E5DA0562794}" dt="2026-03-25T03:03:47.894" v="156" actId="1076"/>
          <ac:picMkLst>
            <pc:docMk/>
            <pc:sldMk cId="3285713202" sldId="256"/>
            <ac:picMk id="26" creationId="{A4041253-5BF3-36C4-B7BD-4539A9EF40A3}"/>
          </ac:picMkLst>
        </pc:picChg>
        <pc:picChg chg="add mod ord">
          <ac:chgData name="辰巳　めぐみ" userId="88b1893c-db63-4bb5-9dca-a6ce3447aab8" providerId="ADAL" clId="{4C98BF49-9253-44F8-8335-0E5DA0562794}" dt="2026-03-25T03:04:14.603" v="162" actId="1076"/>
          <ac:picMkLst>
            <pc:docMk/>
            <pc:sldMk cId="3285713202" sldId="256"/>
            <ac:picMk id="27" creationId="{19889746-E9AD-E9A5-93A2-A9BC68621D4F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EEC0-1DA5-433C-AB0C-50E654322AAD}" type="datetimeFigureOut">
              <a:rPr kumimoji="1" lang="ja-JP" altLang="en-US" smtClean="0"/>
              <a:t>2026/3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63303-1A53-4B44-B900-3B2B2AA3B3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54833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EEC0-1DA5-433C-AB0C-50E654322AAD}" type="datetimeFigureOut">
              <a:rPr kumimoji="1" lang="ja-JP" altLang="en-US" smtClean="0"/>
              <a:t>2026/3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63303-1A53-4B44-B900-3B2B2AA3B3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302223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EEC0-1DA5-433C-AB0C-50E654322AAD}" type="datetimeFigureOut">
              <a:rPr kumimoji="1" lang="ja-JP" altLang="en-US" smtClean="0"/>
              <a:t>2026/3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63303-1A53-4B44-B900-3B2B2AA3B3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164427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EEC0-1DA5-433C-AB0C-50E654322AAD}" type="datetimeFigureOut">
              <a:rPr kumimoji="1" lang="ja-JP" altLang="en-US" smtClean="0"/>
              <a:t>2026/3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63303-1A53-4B44-B900-3B2B2AA3B3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318247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EEC0-1DA5-433C-AB0C-50E654322AAD}" type="datetimeFigureOut">
              <a:rPr kumimoji="1" lang="ja-JP" altLang="en-US" smtClean="0"/>
              <a:t>2026/3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63303-1A53-4B44-B900-3B2B2AA3B3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72653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EEC0-1DA5-433C-AB0C-50E654322AAD}" type="datetimeFigureOut">
              <a:rPr kumimoji="1" lang="ja-JP" altLang="en-US" smtClean="0"/>
              <a:t>2026/3/3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63303-1A53-4B44-B900-3B2B2AA3B3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696310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EEC0-1DA5-433C-AB0C-50E654322AAD}" type="datetimeFigureOut">
              <a:rPr kumimoji="1" lang="ja-JP" altLang="en-US" smtClean="0"/>
              <a:t>2026/3/3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63303-1A53-4B44-B900-3B2B2AA3B3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49265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EEC0-1DA5-433C-AB0C-50E654322AAD}" type="datetimeFigureOut">
              <a:rPr kumimoji="1" lang="ja-JP" altLang="en-US" smtClean="0"/>
              <a:t>2026/3/3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63303-1A53-4B44-B900-3B2B2AA3B3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302504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EEC0-1DA5-433C-AB0C-50E654322AAD}" type="datetimeFigureOut">
              <a:rPr kumimoji="1" lang="ja-JP" altLang="en-US" smtClean="0"/>
              <a:t>2026/3/3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63303-1A53-4B44-B900-3B2B2AA3B3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013292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EEC0-1DA5-433C-AB0C-50E654322AAD}" type="datetimeFigureOut">
              <a:rPr kumimoji="1" lang="ja-JP" altLang="en-US" smtClean="0"/>
              <a:t>2026/3/3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63303-1A53-4B44-B900-3B2B2AA3B3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219854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EEC0-1DA5-433C-AB0C-50E654322AAD}" type="datetimeFigureOut">
              <a:rPr kumimoji="1" lang="ja-JP" altLang="en-US" smtClean="0"/>
              <a:t>2026/3/3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63303-1A53-4B44-B900-3B2B2AA3B3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956204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DEEEC0-1DA5-433C-AB0C-50E654322AAD}" type="datetimeFigureOut">
              <a:rPr kumimoji="1" lang="ja-JP" altLang="en-US" smtClean="0"/>
              <a:t>2026/3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463303-1A53-4B44-B900-3B2B2AA3B3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699791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" name="図 26">
            <a:extLst>
              <a:ext uri="{FF2B5EF4-FFF2-40B4-BE49-F238E27FC236}">
                <a16:creationId xmlns:a16="http://schemas.microsoft.com/office/drawing/2014/main" id="{19889746-E9AD-E9A5-93A2-A9BC68621D4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39017" y="2908754"/>
            <a:ext cx="2053612" cy="2160000"/>
          </a:xfrm>
          <a:prstGeom prst="rect">
            <a:avLst/>
          </a:prstGeom>
        </p:spPr>
      </p:pic>
      <p:pic>
        <p:nvPicPr>
          <p:cNvPr id="26" name="図 25">
            <a:extLst>
              <a:ext uri="{FF2B5EF4-FFF2-40B4-BE49-F238E27FC236}">
                <a16:creationId xmlns:a16="http://schemas.microsoft.com/office/drawing/2014/main" id="{A4041253-5BF3-36C4-B7BD-4539A9EF40A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24269" y="2908754"/>
            <a:ext cx="2050388" cy="2160000"/>
          </a:xfrm>
          <a:prstGeom prst="rect">
            <a:avLst/>
          </a:prstGeom>
        </p:spPr>
      </p:pic>
      <p:pic>
        <p:nvPicPr>
          <p:cNvPr id="25" name="図 24">
            <a:extLst>
              <a:ext uri="{FF2B5EF4-FFF2-40B4-BE49-F238E27FC236}">
                <a16:creationId xmlns:a16="http://schemas.microsoft.com/office/drawing/2014/main" id="{6FD8FB6A-0C8E-A619-0F95-BCD829D560D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672626" y="381579"/>
            <a:ext cx="2047164" cy="2160000"/>
          </a:xfrm>
          <a:prstGeom prst="rect">
            <a:avLst/>
          </a:prstGeom>
        </p:spPr>
      </p:pic>
      <p:pic>
        <p:nvPicPr>
          <p:cNvPr id="24" name="図 23">
            <a:extLst>
              <a:ext uri="{FF2B5EF4-FFF2-40B4-BE49-F238E27FC236}">
                <a16:creationId xmlns:a16="http://schemas.microsoft.com/office/drawing/2014/main" id="{54745168-3CA5-5119-F4D0-30D4D0E88D8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342241" y="381579"/>
            <a:ext cx="2047164" cy="2160000"/>
          </a:xfrm>
          <a:prstGeom prst="rect">
            <a:avLst/>
          </a:prstGeom>
        </p:spPr>
      </p:pic>
      <p:pic>
        <p:nvPicPr>
          <p:cNvPr id="3" name="図 2">
            <a:extLst>
              <a:ext uri="{FF2B5EF4-FFF2-40B4-BE49-F238E27FC236}">
                <a16:creationId xmlns:a16="http://schemas.microsoft.com/office/drawing/2014/main" id="{743BD14A-99BE-64D9-9D9E-03179635751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022737" y="384341"/>
            <a:ext cx="2053453" cy="2160000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131A1956-03FD-E9AD-3AD1-02E5585409FB}"/>
              </a:ext>
            </a:extLst>
          </p:cNvPr>
          <p:cNvSpPr txBox="1"/>
          <p:nvPr/>
        </p:nvSpPr>
        <p:spPr>
          <a:xfrm>
            <a:off x="1144945" y="5323384"/>
            <a:ext cx="6854109" cy="523220"/>
          </a:xfrm>
          <a:prstGeom prst="rect">
            <a:avLst/>
          </a:prstGeom>
          <a:noFill/>
        </p:spPr>
        <p:txBody>
          <a:bodyPr wrap="square" lIns="91440" tIns="45720" rIns="91440" bIns="45720" anchor="t">
            <a:spAutoFit/>
          </a:bodyPr>
          <a:lstStyle/>
          <a:p>
            <a:pPr>
              <a:spcAft>
                <a:spcPts val="1000"/>
              </a:spcAft>
            </a:pPr>
            <a:r>
              <a:rPr lang="en-US" altLang="ja-JP" sz="1400" b="1">
                <a:effectLst/>
                <a:latin typeface="Times"/>
                <a:ea typeface="游明朝"/>
                <a:cs typeface="Times New Roman"/>
              </a:rPr>
              <a:t>Figure </a:t>
            </a:r>
            <a:r>
              <a:rPr lang="en-US" altLang="ja-JP" sz="1400" b="1">
                <a:latin typeface="Times"/>
                <a:ea typeface="游明朝"/>
                <a:cs typeface="Times New Roman"/>
              </a:rPr>
              <a:t>S8</a:t>
            </a:r>
            <a:r>
              <a:rPr lang="en-US" altLang="ja-JP" sz="1400" b="1">
                <a:effectLst/>
                <a:latin typeface="Times"/>
                <a:ea typeface="游明朝"/>
                <a:cs typeface="Times New Roman"/>
              </a:rPr>
              <a:t>.</a:t>
            </a:r>
            <a:r>
              <a:rPr lang="en-US" altLang="ja-JP" sz="1400">
                <a:effectLst/>
                <a:latin typeface="Times"/>
                <a:ea typeface="游明朝"/>
                <a:cs typeface="Times New Roman"/>
              </a:rPr>
              <a:t> </a:t>
            </a:r>
            <a:r>
              <a:rPr lang="en-US" altLang="ja-JP" sz="1400" b="1" dirty="0">
                <a:effectLst/>
                <a:latin typeface="Times"/>
                <a:ea typeface="游明朝"/>
                <a:cs typeface="Times New Roman"/>
              </a:rPr>
              <a:t>Impact of time and temperature before processing on the plasma proteome analyzed by volcano plots.</a:t>
            </a:r>
            <a:endParaRPr lang="ja-JP" altLang="ja-JP" sz="1400" dirty="0">
              <a:effectLst/>
              <a:latin typeface="Times"/>
              <a:ea typeface="游明朝"/>
              <a:cs typeface="Times New Roman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7FEEE800-0508-4675-8EC2-21AB6250A0E1}"/>
              </a:ext>
            </a:extLst>
          </p:cNvPr>
          <p:cNvSpPr txBox="1"/>
          <p:nvPr/>
        </p:nvSpPr>
        <p:spPr>
          <a:xfrm>
            <a:off x="982005" y="167094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7DC1B51B-D354-F865-20A2-34447EFE174A}"/>
              </a:ext>
            </a:extLst>
          </p:cNvPr>
          <p:cNvSpPr txBox="1"/>
          <p:nvPr/>
        </p:nvSpPr>
        <p:spPr>
          <a:xfrm>
            <a:off x="3249251" y="164332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58AEFE1E-E87A-DB83-ED8E-FF31AE45C93D}"/>
              </a:ext>
            </a:extLst>
          </p:cNvPr>
          <p:cNvSpPr txBox="1"/>
          <p:nvPr/>
        </p:nvSpPr>
        <p:spPr>
          <a:xfrm>
            <a:off x="5672626" y="164332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900477FE-C188-CD4F-0062-DC3E14C49563}"/>
              </a:ext>
            </a:extLst>
          </p:cNvPr>
          <p:cNvSpPr txBox="1"/>
          <p:nvPr/>
        </p:nvSpPr>
        <p:spPr>
          <a:xfrm>
            <a:off x="982005" y="2767497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57D07088-5C9A-087F-13B6-1BA29501CDBD}"/>
              </a:ext>
            </a:extLst>
          </p:cNvPr>
          <p:cNvSpPr txBox="1"/>
          <p:nvPr/>
        </p:nvSpPr>
        <p:spPr>
          <a:xfrm>
            <a:off x="3249251" y="2764735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8C81ED12-315A-B18F-7A62-D50B676485BD}"/>
              </a:ext>
            </a:extLst>
          </p:cNvPr>
          <p:cNvSpPr txBox="1"/>
          <p:nvPr/>
        </p:nvSpPr>
        <p:spPr>
          <a:xfrm>
            <a:off x="1540996" y="2465058"/>
            <a:ext cx="124104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kumimoji="1" lang="en-US" altLang="ja-JP" sz="11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fold</a:t>
            </a:r>
            <a:r>
              <a:rPr kumimoji="1" lang="ja-JP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change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EE752302-5691-735D-A786-9E0B34A24C24}"/>
              </a:ext>
            </a:extLst>
          </p:cNvPr>
          <p:cNvSpPr txBox="1"/>
          <p:nvPr/>
        </p:nvSpPr>
        <p:spPr>
          <a:xfrm>
            <a:off x="3841283" y="2460087"/>
            <a:ext cx="124104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kumimoji="1" lang="en-US" altLang="ja-JP" sz="11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fold</a:t>
            </a:r>
            <a:r>
              <a:rPr kumimoji="1" lang="ja-JP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change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B7C75162-B500-BB04-6973-619D0F70000B}"/>
              </a:ext>
            </a:extLst>
          </p:cNvPr>
          <p:cNvSpPr txBox="1"/>
          <p:nvPr/>
        </p:nvSpPr>
        <p:spPr>
          <a:xfrm>
            <a:off x="6255390" y="2455462"/>
            <a:ext cx="124104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kumimoji="1" lang="en-US" altLang="ja-JP" sz="11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fold</a:t>
            </a:r>
            <a:r>
              <a:rPr kumimoji="1" lang="ja-JP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change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BDC676BE-F2FC-FAB4-8576-F5E936CE9A4B}"/>
              </a:ext>
            </a:extLst>
          </p:cNvPr>
          <p:cNvSpPr txBox="1"/>
          <p:nvPr/>
        </p:nvSpPr>
        <p:spPr>
          <a:xfrm rot="16200000">
            <a:off x="408506" y="1344736"/>
            <a:ext cx="107433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-Log</a:t>
            </a:r>
            <a:r>
              <a:rPr kumimoji="1" lang="en-US" altLang="ja-JP" sz="1100" baseline="-25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p-value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0A948114-5735-74E1-3A03-53BE9BB9D2D9}"/>
              </a:ext>
            </a:extLst>
          </p:cNvPr>
          <p:cNvSpPr txBox="1"/>
          <p:nvPr/>
        </p:nvSpPr>
        <p:spPr>
          <a:xfrm rot="16200000">
            <a:off x="2745514" y="1344736"/>
            <a:ext cx="107433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-Log</a:t>
            </a:r>
            <a:r>
              <a:rPr kumimoji="1" lang="en-US" altLang="ja-JP" sz="1100" baseline="-25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p-value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039F5CAD-8409-F30C-B469-18033FFDFF42}"/>
              </a:ext>
            </a:extLst>
          </p:cNvPr>
          <p:cNvSpPr txBox="1"/>
          <p:nvPr/>
        </p:nvSpPr>
        <p:spPr>
          <a:xfrm rot="16200000">
            <a:off x="5043696" y="1379596"/>
            <a:ext cx="107433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-Log</a:t>
            </a:r>
            <a:r>
              <a:rPr kumimoji="1" lang="en-US" altLang="ja-JP" sz="1100" baseline="-25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p-value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775F3FE8-EE4F-93AD-5795-22D7B8B96AE7}"/>
              </a:ext>
            </a:extLst>
          </p:cNvPr>
          <p:cNvSpPr txBox="1"/>
          <p:nvPr/>
        </p:nvSpPr>
        <p:spPr>
          <a:xfrm>
            <a:off x="1540996" y="5018530"/>
            <a:ext cx="124104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kumimoji="1" lang="en-US" altLang="ja-JP" sz="11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fold</a:t>
            </a:r>
            <a:r>
              <a:rPr kumimoji="1" lang="ja-JP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change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F17F86AD-7E65-8BDC-03D2-A9ADEB189BA9}"/>
              </a:ext>
            </a:extLst>
          </p:cNvPr>
          <p:cNvSpPr txBox="1"/>
          <p:nvPr/>
        </p:nvSpPr>
        <p:spPr>
          <a:xfrm>
            <a:off x="3841283" y="5013559"/>
            <a:ext cx="124104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kumimoji="1" lang="en-US" altLang="ja-JP" sz="11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fold</a:t>
            </a:r>
            <a:r>
              <a:rPr kumimoji="1" lang="ja-JP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change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7FDE90A2-4AFE-5068-E628-7099765F56CA}"/>
              </a:ext>
            </a:extLst>
          </p:cNvPr>
          <p:cNvSpPr txBox="1"/>
          <p:nvPr/>
        </p:nvSpPr>
        <p:spPr>
          <a:xfrm rot="16200000">
            <a:off x="408506" y="3864795"/>
            <a:ext cx="107433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-Log</a:t>
            </a:r>
            <a:r>
              <a:rPr kumimoji="1" lang="en-US" altLang="ja-JP" sz="1100" baseline="-25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p-value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CBDBA06D-4F4A-BDE0-9934-B48559C28A6E}"/>
              </a:ext>
            </a:extLst>
          </p:cNvPr>
          <p:cNvSpPr txBox="1"/>
          <p:nvPr/>
        </p:nvSpPr>
        <p:spPr>
          <a:xfrm rot="16200000">
            <a:off x="2738267" y="3864795"/>
            <a:ext cx="107433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-Log</a:t>
            </a:r>
            <a:r>
              <a:rPr kumimoji="1" lang="en-US" altLang="ja-JP" sz="1100" baseline="-25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p-value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857132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09e658bc-5f5e-48b2-a593-8f2a4dff4e86">
      <Terms xmlns="http://schemas.microsoft.com/office/infopath/2007/PartnerControls"/>
    </lcf76f155ced4ddcb4097134ff3c332f>
  </documentManagement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ドキュメント" ma:contentTypeID="0x01010034E485A41FBE0840AEF03DC6126CF7E9" ma:contentTypeVersion="10" ma:contentTypeDescription="新しいドキュメントを作成します。" ma:contentTypeScope="" ma:versionID="b7fc72b48302197a3c00e12c5a71d0f2">
  <xsd:schema xmlns:xsd="http://www.w3.org/2001/XMLSchema" xmlns:xs="http://www.w3.org/2001/XMLSchema" xmlns:p="http://schemas.microsoft.com/office/2006/metadata/properties" xmlns:ns2="09e658bc-5f5e-48b2-a593-8f2a4dff4e86" targetNamespace="http://schemas.microsoft.com/office/2006/metadata/properties" ma:root="true" ma:fieldsID="3811df9a92dabbc9fbde200746e96434" ns2:_="">
    <xsd:import namespace="09e658bc-5f5e-48b2-a593-8f2a4dff4e86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lcf76f155ced4ddcb4097134ff3c332f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ObjectDetectorVersions" minOccurs="0"/>
                <xsd:element ref="ns2:MediaServiceSearchProperties" minOccurs="0"/>
                <xsd:element ref="ns2:MediaServiceDateTake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9e658bc-5f5e-48b2-a593-8f2a4dff4e86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lcf76f155ced4ddcb4097134ff3c332f" ma:index="11" nillable="true" ma:taxonomy="true" ma:internalName="lcf76f155ced4ddcb4097134ff3c332f" ma:taxonomyFieldName="MediaServiceImageTags" ma:displayName="画像タグ" ma:readOnly="false" ma:fieldId="{5cf76f15-5ced-4ddc-b409-7134ff3c332f}" ma:taxonomyMulti="true" ma:sspId="559d5a2e-65d4-4456-94da-aa20a3af47a9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CR" ma:index="12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3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4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bjectDetectorVersions" ma:index="15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16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DateTaken" ma:index="17" nillable="true" ma:displayName="MediaServiceDateTaken" ma:hidden="true" ma:indexed="true" ma:internalName="MediaServiceDateTaken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コンテンツ タイプ"/>
        <xsd:element ref="dc:title" minOccurs="0" maxOccurs="1" ma:index="4" ma:displayName="タイトル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F82237EF-33AE-4882-9504-1CCEA183CAA0}">
  <ds:schemaRefs>
    <ds:schemaRef ds:uri="http://schemas.microsoft.com/office/2006/metadata/properties"/>
    <ds:schemaRef ds:uri="http://schemas.openxmlformats.org/package/2006/metadata/core-properties"/>
    <ds:schemaRef ds:uri="http://purl.org/dc/terms/"/>
    <ds:schemaRef ds:uri="http://purl.org/dc/elements/1.1/"/>
    <ds:schemaRef ds:uri="http://schemas.microsoft.com/office/2006/documentManagement/types"/>
    <ds:schemaRef ds:uri="http://schemas.microsoft.com/office/infopath/2007/PartnerControls"/>
    <ds:schemaRef ds:uri="http://purl.org/dc/dcmitype/"/>
    <ds:schemaRef ds:uri="09e658bc-5f5e-48b2-a593-8f2a4dff4e86"/>
    <ds:schemaRef ds:uri="http://www.w3.org/XML/1998/namespace"/>
  </ds:schemaRefs>
</ds:datastoreItem>
</file>

<file path=customXml/itemProps2.xml><?xml version="1.0" encoding="utf-8"?>
<ds:datastoreItem xmlns:ds="http://schemas.openxmlformats.org/officeDocument/2006/customXml" ds:itemID="{5C05C5B1-A8AB-482C-940E-A38E505A4FDF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608FFA29-EBED-43DA-8FF6-D764B21E94FC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09e658bc-5f5e-48b2-a593-8f2a4dff4e86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66</TotalTime>
  <Words>54</Words>
  <Application>Microsoft Office PowerPoint</Application>
  <PresentationFormat>画面に合わせる (4:3)</PresentationFormat>
  <Paragraphs>16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辰巳　めぐみ</dc:creator>
  <cp:lastModifiedBy>辰巳　めぐみ</cp:lastModifiedBy>
  <cp:revision>10</cp:revision>
  <dcterms:created xsi:type="dcterms:W3CDTF">2025-03-28T03:13:18Z</dcterms:created>
  <dcterms:modified xsi:type="dcterms:W3CDTF">2026-03-31T08:00:1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34E485A41FBE0840AEF03DC6126CF7E9</vt:lpwstr>
  </property>
  <property fmtid="{D5CDD505-2E9C-101B-9397-08002B2CF9AE}" pid="3" name="MediaServiceImageTags">
    <vt:lpwstr/>
  </property>
</Properties>
</file>